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6480175" cy="5761038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60"/>
  </p:normalViewPr>
  <p:slideViewPr>
    <p:cSldViewPr>
      <p:cViewPr>
        <p:scale>
          <a:sx n="50" d="100"/>
          <a:sy n="50" d="100"/>
        </p:scale>
        <p:origin x="-2400" y="-666"/>
      </p:cViewPr>
      <p:guideLst>
        <p:guide orient="horz" pos="1815"/>
        <p:guide pos="204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486014" y="1789657"/>
            <a:ext cx="5508149" cy="123488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972027" y="3264588"/>
            <a:ext cx="4536123" cy="147226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BE30A-8C2C-4138-84BD-9E566C6B5C5A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7DF94-B1BD-41A6-9E02-94D6E6BB24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BE30A-8C2C-4138-84BD-9E566C6B5C5A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7DF94-B1BD-41A6-9E02-94D6E6BB24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330090" y="230710"/>
            <a:ext cx="1032778" cy="4915552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29506" y="230710"/>
            <a:ext cx="2992581" cy="4915552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BE30A-8C2C-4138-84BD-9E566C6B5C5A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7DF94-B1BD-41A6-9E02-94D6E6BB24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BE30A-8C2C-4138-84BD-9E566C6B5C5A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7DF94-B1BD-41A6-9E02-94D6E6BB24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11890" y="3702002"/>
            <a:ext cx="5508149" cy="114420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11890" y="2441774"/>
            <a:ext cx="5508149" cy="126022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BE30A-8C2C-4138-84BD-9E566C6B5C5A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7DF94-B1BD-41A6-9E02-94D6E6BB24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29506" y="1344243"/>
            <a:ext cx="2012680" cy="380201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350190" y="1344243"/>
            <a:ext cx="2012679" cy="380201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BE30A-8C2C-4138-84BD-9E566C6B5C5A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7DF94-B1BD-41A6-9E02-94D6E6BB24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24009" y="230709"/>
            <a:ext cx="5832158" cy="960173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24009" y="1289566"/>
            <a:ext cx="2863203" cy="53743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24009" y="1826996"/>
            <a:ext cx="2863203" cy="331926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291840" y="1289566"/>
            <a:ext cx="2864327" cy="53743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291840" y="1826996"/>
            <a:ext cx="2864327" cy="331926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BE30A-8C2C-4138-84BD-9E566C6B5C5A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7DF94-B1BD-41A6-9E02-94D6E6BB24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BE30A-8C2C-4138-84BD-9E566C6B5C5A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7DF94-B1BD-41A6-9E02-94D6E6BB24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BE30A-8C2C-4138-84BD-9E566C6B5C5A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7DF94-B1BD-41A6-9E02-94D6E6BB24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24009" y="229375"/>
            <a:ext cx="2131933" cy="97617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533568" y="229376"/>
            <a:ext cx="3622598" cy="491688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24009" y="1205552"/>
            <a:ext cx="2131933" cy="394071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BE30A-8C2C-4138-84BD-9E566C6B5C5A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7DF94-B1BD-41A6-9E02-94D6E6BB24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270160" y="4032727"/>
            <a:ext cx="3888105" cy="4760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270160" y="514759"/>
            <a:ext cx="3888105" cy="345662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270160" y="4508813"/>
            <a:ext cx="3888105" cy="67612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BE30A-8C2C-4138-84BD-9E566C6B5C5A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7DF94-B1BD-41A6-9E02-94D6E6BB24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24009" y="230709"/>
            <a:ext cx="5832158" cy="96017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24009" y="1344243"/>
            <a:ext cx="5832158" cy="38020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24010" y="5339630"/>
            <a:ext cx="1512041" cy="3067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BE30A-8C2C-4138-84BD-9E566C6B5C5A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14061" y="5339630"/>
            <a:ext cx="2052055" cy="3067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644126" y="5339630"/>
            <a:ext cx="1512041" cy="3067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7DF94-B1BD-41A6-9E02-94D6E6BB244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61416" y="683985"/>
            <a:ext cx="1606329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5" name="直接箭头连接符 4"/>
          <p:cNvCxnSpPr/>
          <p:nvPr/>
        </p:nvCxnSpPr>
        <p:spPr>
          <a:xfrm>
            <a:off x="1273718" y="2520479"/>
            <a:ext cx="720000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625646" y="2304455"/>
            <a:ext cx="7008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IL-21</a:t>
            </a:r>
            <a:endParaRPr lang="zh-CN" altLang="en-US" sz="2000" b="1" dirty="0"/>
          </a:p>
        </p:txBody>
      </p:sp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81830" y="683985"/>
            <a:ext cx="1606329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866006" y="683985"/>
            <a:ext cx="1606329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TextBox 8"/>
          <p:cNvSpPr txBox="1"/>
          <p:nvPr/>
        </p:nvSpPr>
        <p:spPr>
          <a:xfrm>
            <a:off x="2209822" y="2304455"/>
            <a:ext cx="7425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CD48</a:t>
            </a:r>
            <a:endParaRPr lang="zh-CN" altLang="en-US" sz="2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3793998" y="2304455"/>
            <a:ext cx="9813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/>
              <a:t>CD137L</a:t>
            </a:r>
            <a:endParaRPr lang="zh-CN" altLang="en-US" sz="2000" b="1" dirty="0"/>
          </a:p>
        </p:txBody>
      </p:sp>
      <p:cxnSp>
        <p:nvCxnSpPr>
          <p:cNvPr id="11" name="直接箭头连接符 10"/>
          <p:cNvCxnSpPr/>
          <p:nvPr/>
        </p:nvCxnSpPr>
        <p:spPr>
          <a:xfrm>
            <a:off x="2929902" y="2520479"/>
            <a:ext cx="720000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/>
          <p:cNvCxnSpPr/>
          <p:nvPr/>
        </p:nvCxnSpPr>
        <p:spPr>
          <a:xfrm>
            <a:off x="4730102" y="2520479"/>
            <a:ext cx="720000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-273" y="0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A</a:t>
            </a:r>
            <a:endParaRPr lang="zh-CN" altLang="en-US" sz="2800" b="1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14" name="Rectangle 1"/>
          <p:cNvSpPr>
            <a:spLocks noChangeArrowheads="1"/>
          </p:cNvSpPr>
          <p:nvPr/>
        </p:nvSpPr>
        <p:spPr bwMode="auto">
          <a:xfrm>
            <a:off x="35768" y="3240559"/>
            <a:ext cx="6300663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200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pplementary Figure 1: 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henotypic characterization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of 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engineered K562 cells</a:t>
            </a:r>
            <a:endParaRPr kumimoji="0" lang="en-US" altLang="zh-CN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Engineered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K562 cells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and parental K562 cells were stained with IL-21, CD48 and CD137L antibodies and analyzed using flow </a:t>
            </a:r>
            <a:r>
              <a:rPr lang="en-US" altLang="zh-CN" sz="1200" dirty="0" err="1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ytometry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Representative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ACS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histograms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 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howing IL-21, CD48 and CD137L surface expression on parental K562 cells (blank) and engineered K562 cells (colored). 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39814" y="144215"/>
            <a:ext cx="1294613" cy="198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TextBox 12"/>
          <p:cNvSpPr txBox="1"/>
          <p:nvPr/>
        </p:nvSpPr>
        <p:spPr>
          <a:xfrm>
            <a:off x="-273" y="0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A</a:t>
            </a:r>
            <a:endParaRPr lang="zh-CN" altLang="en-US" sz="2800" b="1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pic>
        <p:nvPicPr>
          <p:cNvPr id="14" name="Picture 3" descr="E:\博士资料库\Heidelberg\AG Schmitt\CAR NK\2021 CAR-NK manuscript\Figures\F1\%NK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295198" y="2368912"/>
            <a:ext cx="1313041" cy="1980000"/>
          </a:xfrm>
          <a:prstGeom prst="rect">
            <a:avLst/>
          </a:prstGeom>
          <a:noFill/>
        </p:spPr>
      </p:pic>
      <p:sp>
        <p:nvSpPr>
          <p:cNvPr id="17" name="TextBox 16"/>
          <p:cNvSpPr txBox="1"/>
          <p:nvPr/>
        </p:nvSpPr>
        <p:spPr>
          <a:xfrm>
            <a:off x="0" y="2152888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B</a:t>
            </a:r>
            <a:endParaRPr lang="zh-CN" altLang="en-US" sz="2800" b="1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pic>
        <p:nvPicPr>
          <p:cNvPr id="24" name="Picture 2" descr="E:\博士资料库\Heidelberg\AG Schmitt\CAR NK\2021 CAR-NK manuscript\Figures\F1\7AAD-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766681" y="2368912"/>
            <a:ext cx="1713766" cy="1980000"/>
          </a:xfrm>
          <a:prstGeom prst="rect">
            <a:avLst/>
          </a:prstGeom>
          <a:noFill/>
        </p:spPr>
      </p:pic>
      <p:sp>
        <p:nvSpPr>
          <p:cNvPr id="25" name="TextBox 24"/>
          <p:cNvSpPr txBox="1"/>
          <p:nvPr/>
        </p:nvSpPr>
        <p:spPr>
          <a:xfrm>
            <a:off x="4523927" y="2152888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C</a:t>
            </a:r>
            <a:endParaRPr lang="zh-CN" altLang="en-US" sz="2800" b="1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6" name="Rectangle 1"/>
          <p:cNvSpPr>
            <a:spLocks noChangeArrowheads="1"/>
          </p:cNvSpPr>
          <p:nvPr/>
        </p:nvSpPr>
        <p:spPr bwMode="auto">
          <a:xfrm>
            <a:off x="0" y="4372362"/>
            <a:ext cx="6480175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200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pplementary Figure 2: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NK cell purity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of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CAR MLNK cells and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AR NK cells. </a:t>
            </a:r>
          </a:p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(A)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The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eripheral blood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BMC or isolated NK cells were stained with CD3 and CD56 antibodies for analysis of NK cell purity (CD3- CD56+) by flow </a:t>
            </a:r>
            <a:r>
              <a:rPr lang="en-US" altLang="zh-CN" sz="1200" dirty="0" err="1" smtClean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ytometry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 The FACS plot showed one representative data from 4 healthy donors. (B) The percentage of CD3- CD56+ cells on CAR </a:t>
            </a:r>
            <a:r>
              <a:rPr lang="en-US" altLang="zh-CN" sz="1200" dirty="0" err="1" smtClean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ransduced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NK cells and CAR </a:t>
            </a:r>
            <a:r>
              <a:rPr lang="en-US" altLang="zh-CN" sz="1200" dirty="0" err="1" smtClean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ransduced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MLNK cells. </a:t>
            </a:r>
            <a:r>
              <a:rPr lang="en-US" altLang="zh-CN" sz="1200" dirty="0" err="1" smtClean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Representive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FACS plots were shown (n=4). (C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) Viability of CAR NK cells and CAR MLNK cells on day 14 were shown.</a:t>
            </a:r>
            <a:endParaRPr kumimoji="0" lang="en-US" altLang="zh-CN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pic>
        <p:nvPicPr>
          <p:cNvPr id="1026" name="Picture 2" descr="E:\博士资料库\Heidelberg\AG Schmitt\CAR NK\2021 CAR-NK manuscript\Figures\Additional files\S F2B.tif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43143" y="2224896"/>
            <a:ext cx="2976824" cy="1800000"/>
          </a:xfrm>
          <a:prstGeom prst="rect">
            <a:avLst/>
          </a:prstGeom>
          <a:noFill/>
        </p:spPr>
      </p:pic>
      <p:pic>
        <p:nvPicPr>
          <p:cNvPr id="1027" name="Picture 3" descr="E:\博士资料库\Heidelberg\AG Schmitt\CAR NK\2021 CAR-NK manuscript\Figures\Additional files\S F2A.tif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87759" y="144215"/>
            <a:ext cx="2975565" cy="1800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 b="65915"/>
          <a:stretch>
            <a:fillRect/>
          </a:stretch>
        </p:blipFill>
        <p:spPr bwMode="auto">
          <a:xfrm>
            <a:off x="479870" y="900671"/>
            <a:ext cx="5856561" cy="15841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b="74667"/>
          <a:stretch>
            <a:fillRect/>
          </a:stretch>
        </p:blipFill>
        <p:spPr bwMode="auto">
          <a:xfrm>
            <a:off x="479870" y="2556854"/>
            <a:ext cx="5825459" cy="154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Box 5"/>
          <p:cNvSpPr txBox="1"/>
          <p:nvPr/>
        </p:nvSpPr>
        <p:spPr>
          <a:xfrm>
            <a:off x="791815" y="576462"/>
            <a:ext cx="907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CAR NK</a:t>
            </a:r>
            <a:endParaRPr lang="zh-CN" alt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2087959" y="576462"/>
            <a:ext cx="1207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CAR MLNK</a:t>
            </a:r>
            <a:endParaRPr lang="zh-CN" alt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744143" y="576462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NT NK</a:t>
            </a:r>
            <a:endParaRPr lang="zh-CN" alt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5112295" y="576462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NT MLNK</a:t>
            </a:r>
            <a:endParaRPr lang="zh-CN" alt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0" y="1008510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D7</a:t>
            </a:r>
            <a:endParaRPr lang="zh-CN" alt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0" y="2592686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D14</a:t>
            </a:r>
            <a:endParaRPr lang="zh-CN" altLang="en-US" b="1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416" y="3483675"/>
            <a:ext cx="800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CD56</a:t>
            </a:r>
            <a:endParaRPr lang="zh-CN" alt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31775" y="3951546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CD16</a:t>
            </a:r>
          </a:p>
        </p:txBody>
      </p:sp>
      <p:cxnSp>
        <p:nvCxnSpPr>
          <p:cNvPr id="14" name="直接箭头连接符 13"/>
          <p:cNvCxnSpPr/>
          <p:nvPr/>
        </p:nvCxnSpPr>
        <p:spPr>
          <a:xfrm>
            <a:off x="587366" y="3960838"/>
            <a:ext cx="57606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 flipV="1">
            <a:off x="575791" y="3384774"/>
            <a:ext cx="0" cy="57606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15751" y="4608910"/>
            <a:ext cx="612068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pplementary Figure </a:t>
            </a:r>
            <a:r>
              <a:rPr lang="en-US" altLang="zh-CN" sz="1200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3: 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D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istribution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NK 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ell 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bsets in CAR NK, CAR MLNK, NT NK 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and 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NT MLNK 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ells. </a:t>
            </a:r>
            <a:endParaRPr lang="en-US" altLang="zh-CN" sz="1200" dirty="0" smtClean="0"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(A) Representativ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low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cytometry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plots showing the distribution of NK cell subtypes in 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AR NK, CAR MLNK, NT NK and NT MLNK 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ells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on day 7 and day 14 of cultivation.</a:t>
            </a:r>
            <a:endParaRPr lang="zh-CN" altLang="en-US" sz="1200" dirty="0"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-273" y="199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A</a:t>
            </a:r>
            <a:endParaRPr lang="zh-CN" altLang="en-US" sz="2800" b="1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6</TotalTime>
  <Words>221</Words>
  <Application>Microsoft Office PowerPoint</Application>
  <PresentationFormat>自定义</PresentationFormat>
  <Paragraphs>22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Company>chin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4</cp:revision>
  <dcterms:created xsi:type="dcterms:W3CDTF">2022-12-13T10:05:46Z</dcterms:created>
  <dcterms:modified xsi:type="dcterms:W3CDTF">2023-03-27T14:10:18Z</dcterms:modified>
</cp:coreProperties>
</file>